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562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ADE708B-3DD9-4F49-ACB3-CCA059FFE1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47D08CE5-D102-4DDB-B785-A806138B45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3756944-C4DB-4C74-B6EC-37656875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39CE7A7B-6039-4EEC-B17D-E9204745B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7BC07F1-3BFD-4457-A331-21D79E7FE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65419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F35BD67D-D386-4A51-B9A9-24F7C7B1E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4E410F99-978D-4D08-BD7C-1233EAF252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2EC91BC-A14F-4F51-94A8-DD144CAE4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89AC065-4918-4D72-9BC0-3E5D06244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B5F1C9BB-1E19-47CD-848B-1ECDDB9B2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24024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E9F85EC9-4130-4AD8-A7EB-8FCA1C2B0F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2F8A2DBA-2C3A-47B1-8754-0A2F828352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8E540616-B659-46C1-99D4-333ECA34B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58028017-EB38-4444-AEF4-E10D079EA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65B31489-E8F0-49B9-BCA1-93EC8C52E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5514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D9C7ED5B-A192-4BBC-9879-89EB2C1A8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AD9A1AEB-B460-413A-9F29-7ACEB92299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D7192DB2-BEA9-4459-9230-B7C29C475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7FB40895-5D49-4882-80A2-FC3AFA00B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F24633AE-B863-454C-A2A8-076B43453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43240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D6F95482-C9C0-4D5F-8737-2E507A4ED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C60A03D3-EAC9-4714-84E3-35D6AEEDF3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C0276EBA-781F-4E5F-B661-37B5A2FCF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40AE8B68-A23E-4AE4-AE97-297444947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EEBAF8D-D04F-4526-8AE2-EADB8D923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24545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A48441-90C3-43B9-939E-2DC1C2C92A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06C7CEAF-6BB8-4DBD-A623-BBF0CFE0B6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B2445BB-644B-4AAD-98FE-70A7FE78CB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0058D8C-2651-43CD-9C9F-CB84B0023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EB0D4FC1-E555-4797-8FC0-4AB227437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27C5FFF2-BE99-4950-B5AD-CA951C5F2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78905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D5CA6DD8-5094-49C9-AF62-4DBF47FAA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C73C71B4-E968-4925-B7D9-782C0D4CC4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E1B9C333-2DCE-4419-942E-A4662627D7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2B1BDFA7-0A42-467E-9D3B-9E45A45FA6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7A334E64-51E4-4DDB-A71C-8D4922F236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2F9BE382-0800-4631-8F52-807420E84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4EE7F5E8-9E4D-4870-A9C0-942B58AFA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A1937508-A81C-4873-9AA6-A30997FA8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18386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D12ED0B-2BAE-408B-8809-33FAC8265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7DE2FA50-5CCE-4282-AD80-679016172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48E36B7E-D6A0-481A-96A6-B9A13F828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6A1F347F-8803-43E9-B166-D165A2FAF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4777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7BB11835-0759-41DF-B9BA-1413F92E4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FEEB2177-FFEF-4B7C-B501-A52E1ECF7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ABE486C9-8FC1-48C9-8563-F40BB450C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72581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CDEC5D2-FFA9-43C7-A6E7-8B014CA90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8A7C11D4-40F8-4811-972A-C48331A25F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5B8E85F9-400D-4871-8F90-78E646108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41474A0D-C159-4007-8783-70A1E7499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4BE333B2-2720-424A-9240-ECC566910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19A0A7E6-2A4D-4CCA-9BBD-339453635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13131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F0B53E93-A025-4151-B75E-15EE46CA0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8C37FCFA-D924-4319-8838-6421C2D0D6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C27DB16-6B8F-497E-86D5-04B4BCA958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E0CB265C-6708-4EB1-BB7F-E95942F54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A6F714DF-CF34-432A-8057-F991BCCD8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AB43A631-7D4F-4F10-A950-C99407841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24648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7B390A71-A035-4F81-A2F5-05D11E80EB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B054E44B-8785-43E9-9C51-725385CD81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9A0E062-704B-40D1-A9EF-3AA3C81046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27F80-2781-4CFF-BE0C-8DC682B256F6}" type="datetimeFigureOut">
              <a:rPr lang="cs-CZ" smtClean="0"/>
              <a:t>14.05.2021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EAA27922-6D7D-4899-A217-6A7EE2762B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0A07A5CC-B742-4047-938F-4A170D5A02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D02CC-6484-4267-9A00-03B153B7BA8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57662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>
            <a:extLst>
              <a:ext uri="{FF2B5EF4-FFF2-40B4-BE49-F238E27FC236}">
                <a16:creationId xmlns:a16="http://schemas.microsoft.com/office/drawing/2014/main" id="{B7D26197-396E-47BD-BC98-EED24E367539}"/>
              </a:ext>
            </a:extLst>
          </p:cNvPr>
          <p:cNvSpPr txBox="1"/>
          <p:nvPr/>
        </p:nvSpPr>
        <p:spPr>
          <a:xfrm>
            <a:off x="271934" y="746448"/>
            <a:ext cx="6232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b="1" u="sng" dirty="0"/>
              <a:t>List </a:t>
            </a:r>
            <a:r>
              <a:rPr lang="cs-CZ" b="1" u="sng" dirty="0" err="1"/>
              <a:t>of</a:t>
            </a:r>
            <a:r>
              <a:rPr lang="cs-CZ" b="1" u="sng" dirty="0"/>
              <a:t> 398 </a:t>
            </a:r>
            <a:r>
              <a:rPr lang="cs-CZ" b="1" u="sng" dirty="0" err="1"/>
              <a:t>genes</a:t>
            </a:r>
            <a:r>
              <a:rPr lang="cs-CZ" b="1" u="sng" dirty="0"/>
              <a:t> in NGS </a:t>
            </a:r>
            <a:r>
              <a:rPr lang="cs-CZ" b="1" u="sng" dirty="0" err="1"/>
              <a:t>short</a:t>
            </a:r>
            <a:r>
              <a:rPr lang="cs-CZ" b="1" u="sng" dirty="0"/>
              <a:t> </a:t>
            </a:r>
            <a:r>
              <a:rPr lang="cs-CZ" b="1" u="sng" dirty="0" err="1"/>
              <a:t>stature</a:t>
            </a:r>
            <a:r>
              <a:rPr lang="cs-CZ" b="1" u="sng" dirty="0"/>
              <a:t> panel</a:t>
            </a:r>
          </a:p>
        </p:txBody>
      </p:sp>
      <p:sp>
        <p:nvSpPr>
          <p:cNvPr id="2" name="Obdélník 1">
            <a:extLst>
              <a:ext uri="{FF2B5EF4-FFF2-40B4-BE49-F238E27FC236}">
                <a16:creationId xmlns:a16="http://schemas.microsoft.com/office/drawing/2014/main" id="{213D3F89-067A-4294-8978-EAEFB92A40E5}"/>
              </a:ext>
            </a:extLst>
          </p:cNvPr>
          <p:cNvSpPr/>
          <p:nvPr/>
        </p:nvSpPr>
        <p:spPr>
          <a:xfrm>
            <a:off x="180680" y="1289097"/>
            <a:ext cx="11830639" cy="55092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cs-CZ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AAS, ACAN, ACP5, ACVR1, ADAMTS10, ADAMTS17, ADAMTSL2, ADAMTSL3, ADIPOQ, AGPS, ALPL, ALS, ALX4, ANAPC13, ANKH, ARID3A, ARID5B, ARNT2, ARSB, ARSE, ATF3, B3GAT3, B4GALT7, BMP2, BMP4, BMP6, BMPR1B, BRCA2, BTK, BTRC, CA2, CABLES1, CASR, CAV1, CBL, CCDC8, CDK5, CDK6, CDKN1C, CETP, CIS, CITED1, CLCN7, CLEC2D, CLEC3B, COL10A1, COL11A1, COL11A2, COL1A1, COL1A2, COL2A1, COL3A1, COL9A1, COL9A2, COL9A3, COMP, CPED1, CR1L, CRIPT, CRTAP, CSF1, CSF1R, CSGALNACT1, CTGF, CTSK, CTSV, CUL4B, CUL7, CXORF5, CYP19A1, CYP27B1, DDR2, DHCR24, DLL3, DLX3, DNA2, DOT1L, DPH1, DTDST, DYM, DYNC2H1, E2F1, E2F3, EBF1, EBP, EFEMP1, EFNB1, EGR1, EGR2, EHMT2, EI24, EIF2AK3, ELN, ERCC6, ERK2, ESCO2, ESR1, ESR2, EVC1, EVC2, EXT1, EXT2, F2, F5, FAM20C, FBLN1, FBLN5, FBN1, FBN2, FBXW8, FGF10, FGF21, FGF23, FGF8, FGF9, FGFR1, FGFR2, FGFR3, FGFR4, FGFRL1, FLNA, FLNB, FLT1, FOS, FUBP1, G6PC, GADD45G, GDF5, GH1, GH2, GHR, GHRH, GHRHR, GHSR, GJA1, GLG1, GLI2, GLI3, GLIS3, GNA12, GNAS, GNAS1, GNPAT, GNRH1, GNRH2, GNRHR, GPR161, GRB10, GRB2, GRHL2, GRK2, GSN, H19, HAPLN1, HDAC4, HESX1, HHIP, HMGA1, HMGA2, HNF1A, HNF1B, HOXA11, HOXD13, HRAS, HS3ST1, HSPG2, HUWE1, CHAD, CHRNA4, CHST3, CHSY1, IARS2, IDUA, IFT172, IFT80, IGF1, IGF1R, IGF2, IGF2BP1, IGFALS, IGFBP3, IGFBP4, IGSF1, IHH, IKBKG, IL11, INPPL1, INS, INSR, IRS1, IRS2, ITGA10, JAK2, JUN, KAL1, KDM5C, KLF4, KRAS, LBR, LEMD3, LFNG, LGALS3, LHX3, LHX4, LIFR, LMBR1, LMNA, LMX1B, LRP5, LTBP1, LTBP3, MAF, MATN1, MATN3, MESP2, METTL1, MGP, MIR140, MIR17, MIR18A, MIR19A, MIR19B1, MIR20A, MMP13, MMP14, MMP16, MMP2, MMP9, MSX2, MT1, MT2, MTHFR, NAB1, NAB2, NBAS, NCAPG, NFIX, NFKB1, NFKB2, NOG, NOS3, NPHS2, NPPC, NPR2, OBSL1, OSTM1, OTX2, P3H1, P63, PAPPA2, PAPSS2, PAX6, PAX8, PCNT, PEX7, PHEX, PI3K, PIAS1, PIAS3, PITX1, PITX2, PKDCC, PLAC1, PLAG1, PLAGL1, PLOD2, PLOD3, PNPLA6, POC1A, POLE, POR, POU1F1, PPARD, PPIB, PPP1R15B, PRG4, PRKAR1A, PRKG2, PRL, PRLR, PRMT7, PROKR2, PROP1, PRRX1, PRRX2, PTGS1, PTGS2, PTH, PTHLH, PTHR1, PTCH1	, PTPN1, PTPN11, PTPN2, PTPN3, PTPN6, PXMP3, RANKL, RBL1, RBL2, RBPJ, RDH11, RECQL, REV3L, RGS10, RIEG, RMRP, RNPC3, ROR2, RPS6, RUNX2, SALL1, SALL4, SBDS, SCMH1, SCUBE2, SCYL1BP1, SEDL, SERPINA3, SF1, SHC1, SHH, SHOX, SIK3, SIRP, SIX3, SKIV2L, SLC34A1, SLC34A3, SLC37A4, SLC39A13, SLC4A4, SMAD3, SMARCAL1, SOCS1, SOCS2, SOCS3, SOS1, SOST, SOX2, SOX3, SOX9, SRC, STAT1, STAT3, STAT4, STAT5, STAT5B, STK3, STK4, SUMO1,TBCE, TBX15, TBX19, TBX2, TBX3, TBX4, TBX5, TBXAS1, TCIRG1, TCPTP, TERT, TGFA, TGFB1, THRA, THRB, TITF1, TLE4, TM7SF2, TMEM16E, TNFRSF11A, TNFRSF11B, TNFSF11, TP53, TP63, TRHR, TRIP11, TRMT10A, TRPS1, TRPV4, TTC37, TWIST1, TWSG1, UBA2, UBP1, USP9X, VDR, WISP3, WNT3, WNT4, WNT7A, XBP1, XPA, XRCC4 ,ZBTB16, ZBTB38, ZMPSTE24, ZNF521</a:t>
            </a:r>
            <a:endParaRPr lang="cs-CZ" sz="1600" dirty="0"/>
          </a:p>
        </p:txBody>
      </p:sp>
    </p:spTree>
    <p:extLst>
      <p:ext uri="{BB962C8B-B14F-4D97-AF65-F5344CB8AC3E}">
        <p14:creationId xmlns:p14="http://schemas.microsoft.com/office/powerpoint/2010/main" val="2763189757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5</Words>
  <Application>Microsoft Office PowerPoint</Application>
  <PresentationFormat>Širokoúhlá obrazovka</PresentationFormat>
  <Paragraphs>2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káš Plachý</dc:creator>
  <cp:lastModifiedBy>Lukáš Plachý</cp:lastModifiedBy>
  <cp:revision>1</cp:revision>
  <dcterms:created xsi:type="dcterms:W3CDTF">2021-05-14T09:57:23Z</dcterms:created>
  <dcterms:modified xsi:type="dcterms:W3CDTF">2021-05-14T09:57:48Z</dcterms:modified>
</cp:coreProperties>
</file>